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796088" cy="992505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E39FB40-0B4C-40CD-A1F7-8711732FF248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10003B5-22CF-45F6-AA76-09E16FE3583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82C32C0-F651-46F4-B972-E61B435F465B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812BF5E-286F-4558-9B77-C6F927F21DAE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F45C6A8-061D-44E7-BA49-820CD3534B8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AAB6C12-DDD6-4B69-9EF2-EA8DCB90F7F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FA5411C-46F5-44BD-80F1-D623D090DFC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6974F12-4698-412F-AFC3-1CE4F4AC253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E4BE392-1B9E-4627-911F-141E0A72EBB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3EDFB4C-09BD-40A3-BE90-FF5833E30CD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CEC3F86-8AEF-46AE-B103-914558B68AA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0FF8FE5-9791-4120-B3B2-025A65D43D1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맑은 고딕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맑은 고딕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맑은 고딕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맑은 고딕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맑은 고딕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맑은 고딕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맑은 고딕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맑은 고딕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ko-KR" sz="1200" spc="-1" strike="noStrike">
                <a:solidFill>
                  <a:srgbClr val="898989"/>
                </a:solidFill>
                <a:latin typeface="맑은 고딕"/>
                <a:ea typeface="맑은 고딕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ko-KR" sz="1200" spc="-1" strike="noStrike">
                <a:solidFill>
                  <a:srgbClr val="898989"/>
                </a:solidFill>
                <a:latin typeface="맑은 고딕"/>
                <a:ea typeface="맑은 고딕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ko-KR" sz="1200" spc="-1" strike="noStrike">
                <a:solidFill>
                  <a:srgbClr val="898989"/>
                </a:solidFill>
                <a:latin typeface="맑은 고딕"/>
                <a:ea typeface="맑은 고딕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1246EB7C-3A9A-4976-A978-C8C8925D8848}" type="slidenum">
              <a:rPr b="0" lang="ko-KR" sz="1200" spc="-1" strike="noStrike">
                <a:solidFill>
                  <a:srgbClr val="898989"/>
                </a:solidFill>
                <a:latin typeface="맑은 고딕"/>
                <a:ea typeface="맑은 고딕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굴림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Rectangle 10"/>
          <p:cNvSpPr/>
          <p:nvPr/>
        </p:nvSpPr>
        <p:spPr>
          <a:xfrm>
            <a:off x="549360" y="4389480"/>
            <a:ext cx="825480" cy="254880"/>
          </a:xfrm>
          <a:prstGeom prst="rect">
            <a:avLst/>
          </a:prstGeom>
          <a:solidFill>
            <a:srgbClr val="ffffff"/>
          </a:solid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36000" rIns="36000" tIns="36000" bIns="360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굴림"/>
              </a:rPr>
              <a:t>Ribosome</a:t>
            </a:r>
            <a:endParaRPr b="0" lang="en-US" sz="1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42" name="TextBox 11"/>
          <p:cNvSpPr/>
          <p:nvPr/>
        </p:nvSpPr>
        <p:spPr>
          <a:xfrm>
            <a:off x="166680" y="4387680"/>
            <a:ext cx="4049640" cy="3373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B</a:t>
            </a:r>
            <a:endParaRPr b="0" lang="en-US" sz="1600" spc="-1" strike="noStrike">
              <a:solidFill>
                <a:srgbClr val="000000"/>
              </a:solidFill>
              <a:latin typeface="굴림"/>
            </a:endParaRPr>
          </a:p>
        </p:txBody>
      </p:sp>
      <p:grpSp>
        <p:nvGrpSpPr>
          <p:cNvPr id="43" name="그룹 1"/>
          <p:cNvGrpSpPr/>
          <p:nvPr/>
        </p:nvGrpSpPr>
        <p:grpSpPr>
          <a:xfrm>
            <a:off x="165240" y="398520"/>
            <a:ext cx="6624360" cy="4059360"/>
            <a:chOff x="165240" y="398520"/>
            <a:chExt cx="6624360" cy="4059360"/>
          </a:xfrm>
        </p:grpSpPr>
        <p:pic>
          <p:nvPicPr>
            <p:cNvPr id="44" name="그림 1" descr=""/>
            <p:cNvPicPr/>
            <p:nvPr/>
          </p:nvPicPr>
          <p:blipFill>
            <a:blip r:embed="rId1"/>
            <a:srcRect l="1700" t="6820" r="1700" b="3622"/>
            <a:stretch/>
          </p:blipFill>
          <p:spPr>
            <a:xfrm>
              <a:off x="165240" y="425520"/>
              <a:ext cx="6624360" cy="403236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45" name="Rectangle 10"/>
            <p:cNvSpPr/>
            <p:nvPr/>
          </p:nvSpPr>
          <p:spPr>
            <a:xfrm>
              <a:off x="236520" y="398520"/>
              <a:ext cx="1876320" cy="144720"/>
            </a:xfrm>
            <a:prstGeom prst="rect">
              <a:avLst/>
            </a:prstGeom>
            <a:solidFill>
              <a:srgbClr val="ffffff"/>
            </a:solidFill>
            <a:ln w="1260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36000" rIns="36000" tIns="36000" bIns="360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굴림"/>
              </a:endParaRPr>
            </a:p>
          </p:txBody>
        </p:sp>
      </p:grpSp>
      <p:grpSp>
        <p:nvGrpSpPr>
          <p:cNvPr id="46" name="그룹 3"/>
          <p:cNvGrpSpPr/>
          <p:nvPr/>
        </p:nvGrpSpPr>
        <p:grpSpPr>
          <a:xfrm>
            <a:off x="549360" y="4579920"/>
            <a:ext cx="5229000" cy="3505320"/>
            <a:chOff x="549360" y="4579920"/>
            <a:chExt cx="5229000" cy="3505320"/>
          </a:xfrm>
        </p:grpSpPr>
        <p:pic>
          <p:nvPicPr>
            <p:cNvPr id="47" name="그림 2" descr=""/>
            <p:cNvPicPr/>
            <p:nvPr/>
          </p:nvPicPr>
          <p:blipFill>
            <a:blip r:embed="rId2"/>
            <a:srcRect l="1701" t="5083" r="1701" b="3723"/>
            <a:stretch/>
          </p:blipFill>
          <p:spPr>
            <a:xfrm>
              <a:off x="549360" y="4646520"/>
              <a:ext cx="5229000" cy="34387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48" name="직사각형 2"/>
            <p:cNvSpPr/>
            <p:nvPr/>
          </p:nvSpPr>
          <p:spPr>
            <a:xfrm>
              <a:off x="554040" y="4579920"/>
              <a:ext cx="620640" cy="22680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굴림"/>
              </a:endParaRPr>
            </a:p>
          </p:txBody>
        </p:sp>
      </p:grpSp>
      <p:sp>
        <p:nvSpPr>
          <p:cNvPr id="49" name="TextBox 11"/>
          <p:cNvSpPr/>
          <p:nvPr/>
        </p:nvSpPr>
        <p:spPr>
          <a:xfrm>
            <a:off x="171360" y="250920"/>
            <a:ext cx="4049640" cy="3373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A</a:t>
            </a:r>
            <a:endParaRPr b="0" lang="en-US" sz="16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50" name="TextBox 11"/>
          <p:cNvSpPr/>
          <p:nvPr/>
        </p:nvSpPr>
        <p:spPr>
          <a:xfrm>
            <a:off x="366840" y="8202600"/>
            <a:ext cx="6221160" cy="824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00000"/>
              </a:lnSpc>
              <a:spcBef>
                <a:spcPts val="30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SUPPLEMENTARY FIGURE 3 |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Ascorbate and aldarate metabolism and ribosome pathways in MRSA treated with NaP.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 (A)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 Ascorbate and aldarate metabolism and 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(B)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 ribosome pathways in MRSA treated with NaP are represented. Green and red highlights indicate up- and down-regulated DEGs in the assigned pathway, respectively.</a:t>
            </a:r>
            <a:endParaRPr b="0" lang="en-US" sz="1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51" name="TextBox 8"/>
          <p:cNvSpPr/>
          <p:nvPr/>
        </p:nvSpPr>
        <p:spPr>
          <a:xfrm>
            <a:off x="1528920" y="-36360"/>
            <a:ext cx="38163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SUPPLEMENTARY FIGURE 3</a:t>
            </a:r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6251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9-01-30T07:45:37Z</dcterms:created>
  <dc:creator>조민경</dc:creator>
  <dc:description/>
  <dc:language>en-US</dc:language>
  <cp:lastModifiedBy>임진택</cp:lastModifiedBy>
  <cp:lastPrinted>2022-01-06T07:05:04Z</cp:lastPrinted>
  <dcterms:modified xsi:type="dcterms:W3CDTF">2022-10-04T08:52:49Z</dcterms:modified>
  <cp:revision>511</cp:revision>
  <dc:subject/>
  <dc:title>슬라이드 1</dc:title>
</cp:coreProperties>
</file>